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2E9921-5C8D-4FB7-B70B-7349E5EE470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8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. Figure 2.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e EGFR-L747S-L858R double mutant is less sensitive to inhibiton by gefitinib and erlotinib.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(a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utophosphorylation of EGFR tyrosine1068 is detected by immunoblots of whole-cell extracts isolated from transfected COS-7 cells after a 3-hour incubation with different concentrations of gefitinib. Total EGFR expression are shown as loading control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b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e inhibition of EGFR autophosphorylation by CL-387,785. Blots were probed with EGFR tyrosine1068 (left) and total EGFR antibody (right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5A211-A6EA-46D3-A7F8-468AD1A5978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0FED66-FA14-4585-911F-5D82B069B3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AF1FC9-D47E-4374-8792-535F117B97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9AB3F8-23F0-47EE-A604-5681624A66C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64AAB-4730-4304-A84C-16138A45B0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1C4A5-772B-4FCB-8512-97EAA136E2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35A3D6-0D71-4142-BE56-B4D64F7C63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71695E-0E89-4112-BAD5-96E969CEF7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D0FA79-4A92-41F1-80D6-DCEEC94023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5236BA-07FF-4440-B0D5-0CA5114216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F96A86-7627-45E3-9295-AF5D4C1E2B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264D78-3276-4F09-8D2B-851B2C38E3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9036AF-5C7E-4367-85B2-26188A0CF79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593640" y="3511440"/>
            <a:ext cx="1200240" cy="25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858R/L747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171440" y="3913200"/>
            <a:ext cx="660600" cy="25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858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00120" y="4276800"/>
            <a:ext cx="1231920" cy="25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858R/T790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840040" y="2724120"/>
            <a:ext cx="172260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L-387,785 (</a:t>
            </a:r>
            <a:r>
              <a:rPr b="1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1"/>
          <a:srcRect l="3843" t="21890" r="3843" b="26063"/>
          <a:stretch/>
        </p:blipFill>
        <p:spPr>
          <a:xfrm>
            <a:off x="1889280" y="3495600"/>
            <a:ext cx="1617480" cy="324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3" name="" descr=""/>
          <p:cNvPicPr/>
          <p:nvPr/>
        </p:nvPicPr>
        <p:blipFill>
          <a:blip r:embed="rId2"/>
          <a:srcRect l="5891" t="13150" r="0" b="27165"/>
          <a:stretch/>
        </p:blipFill>
        <p:spPr>
          <a:xfrm>
            <a:off x="1889280" y="3882960"/>
            <a:ext cx="1617480" cy="324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4" name="" descr=""/>
          <p:cNvPicPr/>
          <p:nvPr/>
        </p:nvPicPr>
        <p:blipFill>
          <a:blip r:embed="rId3"/>
          <a:srcRect l="2320" t="14765" r="2320" b="7964"/>
          <a:stretch/>
        </p:blipFill>
        <p:spPr>
          <a:xfrm>
            <a:off x="3551400" y="3495600"/>
            <a:ext cx="1639800" cy="322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5" name="" descr=""/>
          <p:cNvPicPr/>
          <p:nvPr/>
        </p:nvPicPr>
        <p:blipFill>
          <a:blip r:embed="rId4"/>
          <a:srcRect l="3937" t="16689" r="0" b="0"/>
          <a:stretch/>
        </p:blipFill>
        <p:spPr>
          <a:xfrm>
            <a:off x="3543480" y="3882960"/>
            <a:ext cx="1652400" cy="324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6" name="" descr=""/>
          <p:cNvPicPr/>
          <p:nvPr/>
        </p:nvPicPr>
        <p:blipFill>
          <a:blip r:embed="rId5"/>
          <a:srcRect l="2185" t="0" r="3650" b="9803"/>
          <a:stretch/>
        </p:blipFill>
        <p:spPr>
          <a:xfrm>
            <a:off x="3541680" y="4270320"/>
            <a:ext cx="1650960" cy="322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7" name="" descr=""/>
          <p:cNvPicPr/>
          <p:nvPr/>
        </p:nvPicPr>
        <p:blipFill>
          <a:blip r:embed="rId6"/>
          <a:srcRect l="4235" t="22190" r="28176" b="29205"/>
          <a:stretch/>
        </p:blipFill>
        <p:spPr>
          <a:xfrm>
            <a:off x="1889280" y="4270320"/>
            <a:ext cx="1617480" cy="317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8" name="" descr=""/>
          <p:cNvPicPr/>
          <p:nvPr/>
        </p:nvPicPr>
        <p:blipFill>
          <a:blip r:embed="rId7"/>
          <a:srcRect l="0" t="8134" r="2016" b="10360"/>
          <a:stretch/>
        </p:blipFill>
        <p:spPr>
          <a:xfrm>
            <a:off x="1862280" y="982800"/>
            <a:ext cx="1639800" cy="334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9" name="" descr=""/>
          <p:cNvPicPr/>
          <p:nvPr/>
        </p:nvPicPr>
        <p:blipFill>
          <a:blip r:embed="rId8"/>
          <a:srcRect l="9083" t="13958" r="1811" b="16392"/>
          <a:stretch/>
        </p:blipFill>
        <p:spPr>
          <a:xfrm>
            <a:off x="1862280" y="1384200"/>
            <a:ext cx="1639800" cy="336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0" name="" descr=""/>
          <p:cNvPicPr/>
          <p:nvPr/>
        </p:nvPicPr>
        <p:blipFill>
          <a:blip r:embed="rId9"/>
          <a:srcRect l="5346" t="12617" r="7157" b="18091"/>
          <a:stretch/>
        </p:blipFill>
        <p:spPr>
          <a:xfrm>
            <a:off x="1862280" y="1785960"/>
            <a:ext cx="1639800" cy="349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1" name=""/>
          <p:cNvSpPr/>
          <p:nvPr/>
        </p:nvSpPr>
        <p:spPr>
          <a:xfrm>
            <a:off x="2056320" y="2266920"/>
            <a:ext cx="1404360" cy="25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hospho-EG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rot="18815400">
            <a:off x="1959120" y="664920"/>
            <a:ext cx="43992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8815400">
            <a:off x="2264040" y="630000"/>
            <a:ext cx="53784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0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rot="18815400">
            <a:off x="2571120" y="653040"/>
            <a:ext cx="46368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rot="18815400">
            <a:off x="2929320" y="683640"/>
            <a:ext cx="38232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rot="18815400">
            <a:off x="3231000" y="685080"/>
            <a:ext cx="38268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743200" y="190440"/>
            <a:ext cx="167940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efitinib (</a:t>
            </a:r>
            <a:r>
              <a:rPr b="1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rot="18815400">
            <a:off x="3604320" y="666720"/>
            <a:ext cx="43524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rot="18815400">
            <a:off x="3912120" y="634680"/>
            <a:ext cx="52236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0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rot="18815400">
            <a:off x="4225320" y="653040"/>
            <a:ext cx="46368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18815400">
            <a:off x="4577040" y="685080"/>
            <a:ext cx="38268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rot="18815400">
            <a:off x="4875480" y="685080"/>
            <a:ext cx="38268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655800" y="2266920"/>
            <a:ext cx="1061280" cy="25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otal EG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" descr=""/>
          <p:cNvPicPr/>
          <p:nvPr/>
        </p:nvPicPr>
        <p:blipFill>
          <a:blip r:embed="rId10">
            <a:grayscl/>
          </a:blip>
          <a:srcRect l="3760" t="9091" r="3760" b="-10880"/>
          <a:stretch/>
        </p:blipFill>
        <p:spPr>
          <a:xfrm>
            <a:off x="3540240" y="1384200"/>
            <a:ext cx="1638360" cy="341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5" name="" descr=""/>
          <p:cNvPicPr/>
          <p:nvPr/>
        </p:nvPicPr>
        <p:blipFill>
          <a:blip r:embed="rId11">
            <a:grayscl/>
          </a:blip>
          <a:srcRect l="6009" t="9091" r="3760" b="10952"/>
          <a:stretch/>
        </p:blipFill>
        <p:spPr>
          <a:xfrm>
            <a:off x="3541680" y="982800"/>
            <a:ext cx="1639800" cy="333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6" name="" descr=""/>
          <p:cNvPicPr/>
          <p:nvPr/>
        </p:nvPicPr>
        <p:blipFill>
          <a:blip r:embed="rId12">
            <a:grayscl/>
          </a:blip>
          <a:srcRect l="2250" t="0" r="7519" b="0"/>
          <a:stretch/>
        </p:blipFill>
        <p:spPr>
          <a:xfrm>
            <a:off x="3549600" y="1785960"/>
            <a:ext cx="1631880" cy="338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7" name=""/>
          <p:cNvSpPr/>
          <p:nvPr/>
        </p:nvSpPr>
        <p:spPr>
          <a:xfrm>
            <a:off x="533880" y="155520"/>
            <a:ext cx="311760" cy="41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2680" bIns="226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95720" y="2573280"/>
            <a:ext cx="311760" cy="41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2680" bIns="226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6362640" y="190440"/>
            <a:ext cx="181440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rlotinib (</a:t>
            </a:r>
            <a:r>
              <a:rPr b="1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" descr=""/>
          <p:cNvPicPr/>
          <p:nvPr/>
        </p:nvPicPr>
        <p:blipFill>
          <a:blip r:embed="rId13"/>
          <a:srcRect l="4040" t="23832" r="0" b="23832"/>
          <a:stretch/>
        </p:blipFill>
        <p:spPr>
          <a:xfrm>
            <a:off x="5257800" y="1781280"/>
            <a:ext cx="1622520" cy="336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1" name="" descr=""/>
          <p:cNvPicPr/>
          <p:nvPr/>
        </p:nvPicPr>
        <p:blipFill>
          <a:blip r:embed="rId14"/>
          <a:srcRect l="3644" t="19613" r="9098" b="22978"/>
          <a:stretch/>
        </p:blipFill>
        <p:spPr>
          <a:xfrm>
            <a:off x="5257800" y="1400040"/>
            <a:ext cx="1622520" cy="338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2" name="" descr=""/>
          <p:cNvPicPr/>
          <p:nvPr/>
        </p:nvPicPr>
        <p:blipFill>
          <a:blip r:embed="rId15"/>
          <a:srcRect l="0" t="23550" r="17251" b="17681"/>
          <a:stretch/>
        </p:blipFill>
        <p:spPr>
          <a:xfrm>
            <a:off x="5257800" y="981000"/>
            <a:ext cx="1622520" cy="3398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3" name="" descr=""/>
          <p:cNvPicPr/>
          <p:nvPr/>
        </p:nvPicPr>
        <p:blipFill>
          <a:blip r:embed="rId16"/>
          <a:srcRect l="5166" t="32277" r="10360" b="22346"/>
          <a:stretch/>
        </p:blipFill>
        <p:spPr>
          <a:xfrm>
            <a:off x="6934320" y="981000"/>
            <a:ext cx="1658880" cy="3398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4" name="" descr=""/>
          <p:cNvPicPr/>
          <p:nvPr/>
        </p:nvPicPr>
        <p:blipFill>
          <a:blip r:embed="rId17"/>
          <a:srcRect l="5445" t="26100" r="5445" b="30425"/>
          <a:stretch/>
        </p:blipFill>
        <p:spPr>
          <a:xfrm>
            <a:off x="6934320" y="1781280"/>
            <a:ext cx="1658880" cy="338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5" name="" descr=""/>
          <p:cNvPicPr/>
          <p:nvPr/>
        </p:nvPicPr>
        <p:blipFill>
          <a:blip r:embed="rId18"/>
          <a:srcRect l="6870" t="22085" r="10528" b="22703"/>
          <a:stretch/>
        </p:blipFill>
        <p:spPr>
          <a:xfrm>
            <a:off x="6934320" y="1400040"/>
            <a:ext cx="1658880" cy="338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6" name=""/>
          <p:cNvSpPr/>
          <p:nvPr/>
        </p:nvSpPr>
        <p:spPr>
          <a:xfrm rot="18815400">
            <a:off x="5339160" y="663120"/>
            <a:ext cx="43956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rot="18815400">
            <a:off x="5644080" y="628200"/>
            <a:ext cx="53820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0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rot="18815400">
            <a:off x="5960880" y="651240"/>
            <a:ext cx="46332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rot="18815400">
            <a:off x="6312240" y="685080"/>
            <a:ext cx="38268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rot="18815400">
            <a:off x="6610680" y="683640"/>
            <a:ext cx="38232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rot="18815400">
            <a:off x="7015680" y="663120"/>
            <a:ext cx="43956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rot="18815400">
            <a:off x="7320240" y="628200"/>
            <a:ext cx="53820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0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rot="18815400">
            <a:off x="7637040" y="651240"/>
            <a:ext cx="46332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rot="18815400">
            <a:off x="7988760" y="685080"/>
            <a:ext cx="38268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rot="18815400">
            <a:off x="8287200" y="683640"/>
            <a:ext cx="38232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866960" y="485640"/>
            <a:ext cx="32385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5257800" y="485640"/>
            <a:ext cx="32385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rot="18815400">
            <a:off x="1951920" y="3180240"/>
            <a:ext cx="44136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rot="18815400">
            <a:off x="2256120" y="3142800"/>
            <a:ext cx="53820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0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rot="18815400">
            <a:off x="2560320" y="3165480"/>
            <a:ext cx="46692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rot="18815400">
            <a:off x="2923560" y="3200760"/>
            <a:ext cx="38412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rot="18815400">
            <a:off x="3222000" y="3199320"/>
            <a:ext cx="38412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rot="18815400">
            <a:off x="3599640" y="3181320"/>
            <a:ext cx="43524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rot="18815400">
            <a:off x="3907080" y="3149280"/>
            <a:ext cx="52236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0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 rot="18815400">
            <a:off x="4210920" y="3167640"/>
            <a:ext cx="46368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rot="18815400">
            <a:off x="4569120" y="3198240"/>
            <a:ext cx="38232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 rot="18815400">
            <a:off x="4872600" y="3199680"/>
            <a:ext cx="38268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1862280" y="3019320"/>
            <a:ext cx="32382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5485320" y="2266920"/>
            <a:ext cx="1404360" cy="25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hospho-EG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7084800" y="2266920"/>
            <a:ext cx="1061280" cy="25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otal EG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980000" y="4743360"/>
            <a:ext cx="1404360" cy="25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hospho-EG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3798720" y="4743360"/>
            <a:ext cx="1061280" cy="25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otal EG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546120" y="1025640"/>
            <a:ext cx="1200240" cy="25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858R/L747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123920" y="1427040"/>
            <a:ext cx="660600" cy="25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858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552600" y="1790640"/>
            <a:ext cx="1231920" cy="25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858R/T790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503280" y="5102280"/>
            <a:ext cx="81500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ementary Figure S2. The EGFR-L747S-L858R double mutant is less sensitive to inhibiton by gefitinib and erlotinib. (A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utophosphorylation of EGFR tyrosine1068 is detected by immunoblots of whole-cell extracts isolated from transfected COS-7 cells after a 3-hour incubation with different concentrations of gefitinib. Total EGFR expression are shown as loading control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B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e inhibition of EGFR autophosphorylation by CL-387,785. Blots were probed with EGFR tyrosine1068 (left) and total EGFR antibody (right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9-07T12:30:13Z</dcterms:created>
  <dc:creator>SClark</dc:creator>
  <dc:description/>
  <dc:language>en-US</dc:language>
  <cp:lastModifiedBy>SClark</cp:lastModifiedBy>
  <dcterms:modified xsi:type="dcterms:W3CDTF">2007-09-07T12:30:19Z</dcterms:modified>
  <cp:revision>1</cp:revision>
  <dc:subject/>
  <dc:title>Slide 1</dc:title>
</cp:coreProperties>
</file>